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48" d="100"/>
          <a:sy n="48" d="100"/>
        </p:scale>
        <p:origin x="-2316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3403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516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005423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0783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38430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2465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77868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60577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93402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2708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42641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8103F8-A80B-48E0-BFC6-D0ED0EDA04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2FABE9-C95E-4320-815B-7098DC46079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5403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xmlns="" id="{075E4CD7-1D70-2B43-84C9-3764EE7AA8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910" y="1318846"/>
            <a:ext cx="0" cy="0"/>
          </a:xfrm>
          <a:prstGeom prst="rect">
            <a:avLst/>
          </a:prstGeom>
        </p:spPr>
      </p:pic>
      <p:graphicFrame>
        <p:nvGraphicFramePr>
          <p:cNvPr id="7" name="Tabella 6">
            <a:extLst>
              <a:ext uri="{FF2B5EF4-FFF2-40B4-BE49-F238E27FC236}">
                <a16:creationId xmlns:a16="http://schemas.microsoft.com/office/drawing/2014/main" xmlns="" id="{43346229-7599-BA44-9DCB-5C13B206BE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53406490"/>
              </p:ext>
            </p:extLst>
          </p:nvPr>
        </p:nvGraphicFramePr>
        <p:xfrm>
          <a:off x="318294" y="446147"/>
          <a:ext cx="6221412" cy="5463077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799306">
                  <a:extLst>
                    <a:ext uri="{9D8B030D-6E8A-4147-A177-3AD203B41FA5}">
                      <a16:colId xmlns:a16="http://schemas.microsoft.com/office/drawing/2014/main" xmlns="" val="352967713"/>
                    </a:ext>
                  </a:extLst>
                </a:gridCol>
                <a:gridCol w="2768600">
                  <a:extLst>
                    <a:ext uri="{9D8B030D-6E8A-4147-A177-3AD203B41FA5}">
                      <a16:colId xmlns:a16="http://schemas.microsoft.com/office/drawing/2014/main" xmlns="" val="1820637863"/>
                    </a:ext>
                  </a:extLst>
                </a:gridCol>
                <a:gridCol w="2653506">
                  <a:extLst>
                    <a:ext uri="{9D8B030D-6E8A-4147-A177-3AD203B41FA5}">
                      <a16:colId xmlns:a16="http://schemas.microsoft.com/office/drawing/2014/main" xmlns="" val="3588546009"/>
                    </a:ext>
                  </a:extLst>
                </a:gridCol>
              </a:tblGrid>
              <a:tr h="241251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it-IT" sz="9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ward sequence</a:t>
                      </a:r>
                      <a:endParaRPr lang="it-IT" sz="900" b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e </a:t>
                      </a:r>
                      <a:r>
                        <a:rPr lang="it-IT" sz="900" b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endParaRPr lang="it-IT" sz="9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3240661410"/>
                  </a:ext>
                </a:extLst>
              </a:tr>
              <a:tr h="4340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mox1</a:t>
                      </a:r>
                      <a:endParaRPr lang="it-IT" sz="900" b="1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8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CTGGTGCAAGATACTGCCC-3</a:t>
                      </a:r>
                      <a:r>
                        <a:rPr lang="it-IT" sz="900" spc="3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6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GGGGCCAGTATTGCATTT-3</a:t>
                      </a:r>
                      <a:r>
                        <a:rPr lang="it-IT" sz="900" spc="1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2953477143"/>
                  </a:ext>
                </a:extLst>
              </a:tr>
              <a:tr h="4340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ldo1</a:t>
                      </a:r>
                      <a:endParaRPr lang="it-IT" sz="900" b="1" i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4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CACAGAAGTTGATGCAAGGC-3</a:t>
                      </a:r>
                      <a:r>
                        <a:rPr lang="it-IT" sz="900" spc="11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1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 GTTCCTCCAGCTCCTTTCCAG- 3</a:t>
                      </a:r>
                      <a:r>
                        <a:rPr lang="it-IT" sz="900" spc="2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369042892"/>
                  </a:ext>
                </a:extLst>
              </a:tr>
              <a:tr h="4340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kt</a:t>
                      </a:r>
                      <a:endParaRPr lang="it-IT" sz="900" b="1" i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8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CAAAGCCAGCTACCGAGTC-3</a:t>
                      </a:r>
                      <a:r>
                        <a:rPr lang="it-IT" sz="900" spc="3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6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GCTTCTGGTAGATGTCCA-3</a:t>
                      </a:r>
                      <a:r>
                        <a:rPr lang="it-IT" sz="900" spc="65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37442717"/>
                  </a:ext>
                </a:extLst>
              </a:tr>
              <a:tr h="4340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1</a:t>
                      </a:r>
                      <a:endParaRPr lang="it-IT" sz="900" b="1" i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9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CAGTCGCTGTTACCGTATG-3</a:t>
                      </a:r>
                      <a:r>
                        <a:rPr lang="it-IT" sz="900" spc="10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1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ATAACCCTCTTCACTCTGGAC-3</a:t>
                      </a:r>
                      <a:r>
                        <a:rPr lang="it-IT" sz="900" spc="3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4169586072"/>
                  </a:ext>
                </a:extLst>
              </a:tr>
              <a:tr h="44067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rg1</a:t>
                      </a:r>
                      <a:endParaRPr lang="it-IT" sz="900" b="1" i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CCAAAGAGATTCCACCCTCCCTCT-3</a:t>
                      </a:r>
                      <a:r>
                        <a:rPr lang="it-IT" sz="900" spc="23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45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TATGGGTGCCCCTGCGTG-3’</a:t>
                      </a:r>
                      <a:endParaRPr lang="it-IT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3740629678"/>
                  </a:ext>
                </a:extLst>
              </a:tr>
              <a:tr h="4340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67</a:t>
                      </a:r>
                      <a:endParaRPr lang="it-IT" sz="900" b="1" i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95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AGAGCTAACTTGCGCTGACT-3</a:t>
                      </a:r>
                      <a:r>
                        <a:rPr lang="it-IT" sz="900" spc="6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'</a:t>
                      </a:r>
                      <a:endParaRPr lang="it-IT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TCAATACTCCTTCCAAACAGGCA-3</a:t>
                      </a:r>
                      <a:r>
                        <a:rPr lang="it-IT" sz="900" spc="17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'</a:t>
                      </a:r>
                      <a:endParaRPr lang="it-IT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1728812526"/>
                  </a:ext>
                </a:extLst>
              </a:tr>
              <a:tr h="4340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1β</a:t>
                      </a:r>
                      <a:endParaRPr lang="it-IT" sz="900" b="1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6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CCACCTTTTGACAGTGATG-3</a:t>
                      </a:r>
                      <a:r>
                        <a:rPr lang="it-IT" sz="900" spc="12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5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TGCGAGATTTGAAGCTGG-3</a:t>
                      </a:r>
                      <a:r>
                        <a:rPr lang="it-IT" sz="900" spc="11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1066259085"/>
                  </a:ext>
                </a:extLst>
              </a:tr>
              <a:tr h="44067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L-6</a:t>
                      </a:r>
                      <a:endParaRPr lang="it-IT" sz="900" b="1" i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TGGATATAATCAGGAAATTTGCCT-3</a:t>
                      </a:r>
                      <a:r>
                        <a:rPr lang="it-IT" sz="900" spc="2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GGGTAGGAAGGACTATTTTATGT-3</a:t>
                      </a:r>
                      <a:r>
                        <a:rPr lang="it-IT" sz="900" spc="21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1301179752"/>
                  </a:ext>
                </a:extLst>
              </a:tr>
              <a:tr h="4340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NFα</a:t>
                      </a:r>
                      <a:endParaRPr lang="it-IT" sz="900" b="1" i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12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CCACGTCGTAGCAAACC-3</a:t>
                      </a:r>
                      <a:r>
                        <a:rPr lang="it-IT" sz="900" spc="1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7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TGAGGAGCACGTAGTCGG-3</a:t>
                      </a:r>
                      <a:r>
                        <a:rPr lang="it-IT" sz="900" spc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255130744"/>
                  </a:ext>
                </a:extLst>
              </a:tr>
              <a:tr h="4340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qo1</a:t>
                      </a:r>
                      <a:endParaRPr lang="it-IT" sz="900" b="1" i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12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GCCGATTCAGAGTGGCAT-3</a:t>
                      </a:r>
                      <a:r>
                        <a:rPr lang="it-IT" sz="900" spc="1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6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CAGACGGTTTCCAGACGTT-3</a:t>
                      </a:r>
                      <a:r>
                        <a:rPr lang="it-IT" sz="900" spc="6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3264978144"/>
                  </a:ext>
                </a:extLst>
              </a:tr>
              <a:tr h="4340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pat</a:t>
                      </a:r>
                      <a:endParaRPr lang="it-IT" sz="900" b="1" i="1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12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AGTAGCGCGAGCCTCTTG-3</a:t>
                      </a:r>
                      <a:r>
                        <a:rPr lang="it-IT" sz="900" spc="1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6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CCTGACCTCGGTGCTGTAG-3</a:t>
                      </a:r>
                      <a:r>
                        <a:rPr lang="it-IT" sz="900" spc="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’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2787921190"/>
                  </a:ext>
                </a:extLst>
              </a:tr>
              <a:tr h="43404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t-IT" sz="9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b4</a:t>
                      </a:r>
                      <a:endParaRPr lang="it-IT" sz="900" b="1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8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GGCGACCTGGAAGTCCAACT-3</a:t>
                      </a:r>
                      <a:r>
                        <a:rPr lang="it-IT" sz="900" spc="95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'</a:t>
                      </a:r>
                      <a:endParaRPr lang="it-IT" sz="9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it-IT" sz="900" spc="65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CCATCAGCACCACAGCCTTC-3</a:t>
                      </a:r>
                      <a:r>
                        <a:rPr lang="it-IT" sz="900" spc="2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'</a:t>
                      </a:r>
                      <a:endParaRPr lang="it-IT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9675" marR="59675" marT="0" marB="0" anchor="ctr"/>
                </a:tc>
                <a:extLst>
                  <a:ext uri="{0D108BD9-81ED-4DB2-BD59-A6C34878D82A}">
                    <a16:rowId xmlns:a16="http://schemas.microsoft.com/office/drawing/2014/main" xmlns="" val="680373123"/>
                  </a:ext>
                </a:extLst>
              </a:tr>
            </a:tbl>
          </a:graphicData>
        </a:graphic>
      </p:graphicFrame>
      <p:sp>
        <p:nvSpPr>
          <p:cNvPr id="8" name="Rettangolo 7">
            <a:extLst>
              <a:ext uri="{FF2B5EF4-FFF2-40B4-BE49-F238E27FC236}">
                <a16:creationId xmlns:a16="http://schemas.microsoft.com/office/drawing/2014/main" xmlns="" id="{8BE416C0-BC3D-764D-A9D7-0742FE9582C4}"/>
              </a:ext>
            </a:extLst>
          </p:cNvPr>
          <p:cNvSpPr/>
          <p:nvPr/>
        </p:nvSpPr>
        <p:spPr>
          <a:xfrm>
            <a:off x="165100" y="6164434"/>
            <a:ext cx="5700713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1- DNA  sequences of forward and reverse primer used for Real Time PCR analysis.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7756367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1</Words>
  <Application>Microsoft Office PowerPoint</Application>
  <PresentationFormat>Presentazione su schermo (4:3)</PresentationFormat>
  <Paragraphs>4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elisabetta vegeto</dc:creator>
  <cp:lastModifiedBy>elisabetta vegeto</cp:lastModifiedBy>
  <cp:revision>1</cp:revision>
  <dcterms:created xsi:type="dcterms:W3CDTF">2020-07-10T16:45:12Z</dcterms:created>
  <dcterms:modified xsi:type="dcterms:W3CDTF">2020-07-10T16:45:31Z</dcterms:modified>
</cp:coreProperties>
</file>